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2599988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2" d="100"/>
          <a:sy n="62" d="100"/>
        </p:scale>
        <p:origin x="75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74999" y="1237197"/>
            <a:ext cx="9449991" cy="2631887"/>
          </a:xfrm>
        </p:spPr>
        <p:txBody>
          <a:bodyPr anchor="b"/>
          <a:lstStyle>
            <a:lvl1pPr algn="ctr">
              <a:defRPr sz="620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3970580"/>
            <a:ext cx="9449991" cy="1825171"/>
          </a:xfrm>
        </p:spPr>
        <p:txBody>
          <a:bodyPr/>
          <a:lstStyle>
            <a:lvl1pPr marL="0" indent="0" algn="ctr">
              <a:buNone/>
              <a:defRPr sz="2480"/>
            </a:lvl1pPr>
            <a:lvl2pPr marL="472516" indent="0" algn="ctr">
              <a:buNone/>
              <a:defRPr sz="2067"/>
            </a:lvl2pPr>
            <a:lvl3pPr marL="945032" indent="0" algn="ctr">
              <a:buNone/>
              <a:defRPr sz="1860"/>
            </a:lvl3pPr>
            <a:lvl4pPr marL="1417549" indent="0" algn="ctr">
              <a:buNone/>
              <a:defRPr sz="1654"/>
            </a:lvl4pPr>
            <a:lvl5pPr marL="1890065" indent="0" algn="ctr">
              <a:buNone/>
              <a:defRPr sz="1654"/>
            </a:lvl5pPr>
            <a:lvl6pPr marL="2362581" indent="0" algn="ctr">
              <a:buNone/>
              <a:defRPr sz="1654"/>
            </a:lvl6pPr>
            <a:lvl7pPr marL="2835097" indent="0" algn="ctr">
              <a:buNone/>
              <a:defRPr sz="1654"/>
            </a:lvl7pPr>
            <a:lvl8pPr marL="3307613" indent="0" algn="ctr">
              <a:buNone/>
              <a:defRPr sz="1654"/>
            </a:lvl8pPr>
            <a:lvl9pPr marL="3780130" indent="0" algn="ctr">
              <a:buNone/>
              <a:defRPr sz="1654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69155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23331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402483"/>
            <a:ext cx="2716872" cy="64064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49" y="402483"/>
            <a:ext cx="7993117" cy="6406475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91889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51076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1884670"/>
            <a:ext cx="10867490" cy="3144614"/>
          </a:xfrm>
        </p:spPr>
        <p:txBody>
          <a:bodyPr anchor="b"/>
          <a:lstStyle>
            <a:lvl1pPr>
              <a:defRPr sz="620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5059034"/>
            <a:ext cx="10867490" cy="1653678"/>
          </a:xfrm>
        </p:spPr>
        <p:txBody>
          <a:bodyPr/>
          <a:lstStyle>
            <a:lvl1pPr marL="0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1pPr>
            <a:lvl2pPr marL="472516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2pPr>
            <a:lvl3pPr marL="945032" indent="0">
              <a:buNone/>
              <a:defRPr sz="1860">
                <a:solidFill>
                  <a:schemeClr val="tx1">
                    <a:tint val="75000"/>
                  </a:schemeClr>
                </a:solidFill>
              </a:defRPr>
            </a:lvl3pPr>
            <a:lvl4pPr marL="1417549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4pPr>
            <a:lvl5pPr marL="1890065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5pPr>
            <a:lvl6pPr marL="2362581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6pPr>
            <a:lvl7pPr marL="2835097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7pPr>
            <a:lvl8pPr marL="3307613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8pPr>
            <a:lvl9pPr marL="3780130" indent="0">
              <a:buNone/>
              <a:defRPr sz="16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897138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012414"/>
            <a:ext cx="5354995" cy="479654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012414"/>
            <a:ext cx="5354995" cy="479654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23383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402483"/>
            <a:ext cx="10867490" cy="146118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1" y="1853171"/>
            <a:ext cx="5330385" cy="908210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1" y="2761381"/>
            <a:ext cx="5330385" cy="40615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4" y="1853171"/>
            <a:ext cx="5356636" cy="908210"/>
          </a:xfrm>
        </p:spPr>
        <p:txBody>
          <a:bodyPr anchor="b"/>
          <a:lstStyle>
            <a:lvl1pPr marL="0" indent="0">
              <a:buNone/>
              <a:defRPr sz="2480" b="1"/>
            </a:lvl1pPr>
            <a:lvl2pPr marL="472516" indent="0">
              <a:buNone/>
              <a:defRPr sz="2067" b="1"/>
            </a:lvl2pPr>
            <a:lvl3pPr marL="945032" indent="0">
              <a:buNone/>
              <a:defRPr sz="1860" b="1"/>
            </a:lvl3pPr>
            <a:lvl4pPr marL="1417549" indent="0">
              <a:buNone/>
              <a:defRPr sz="1654" b="1"/>
            </a:lvl4pPr>
            <a:lvl5pPr marL="1890065" indent="0">
              <a:buNone/>
              <a:defRPr sz="1654" b="1"/>
            </a:lvl5pPr>
            <a:lvl6pPr marL="2362581" indent="0">
              <a:buNone/>
              <a:defRPr sz="1654" b="1"/>
            </a:lvl6pPr>
            <a:lvl7pPr marL="2835097" indent="0">
              <a:buNone/>
              <a:defRPr sz="1654" b="1"/>
            </a:lvl7pPr>
            <a:lvl8pPr marL="3307613" indent="0">
              <a:buNone/>
              <a:defRPr sz="1654" b="1"/>
            </a:lvl8pPr>
            <a:lvl9pPr marL="3780130" indent="0">
              <a:buNone/>
              <a:defRPr sz="1654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4" y="2761381"/>
            <a:ext cx="5356636" cy="406157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54217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75202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40917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503978"/>
            <a:ext cx="4063824" cy="1763924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088454"/>
            <a:ext cx="6378744" cy="5372269"/>
          </a:xfrm>
        </p:spPr>
        <p:txBody>
          <a:bodyPr/>
          <a:lstStyle>
            <a:lvl1pPr>
              <a:defRPr sz="3307"/>
            </a:lvl1pPr>
            <a:lvl2pPr>
              <a:defRPr sz="2894"/>
            </a:lvl2pPr>
            <a:lvl3pPr>
              <a:defRPr sz="2480"/>
            </a:lvl3pPr>
            <a:lvl4pPr>
              <a:defRPr sz="2067"/>
            </a:lvl4pPr>
            <a:lvl5pPr>
              <a:defRPr sz="2067"/>
            </a:lvl5pPr>
            <a:lvl6pPr>
              <a:defRPr sz="2067"/>
            </a:lvl6pPr>
            <a:lvl7pPr>
              <a:defRPr sz="2067"/>
            </a:lvl7pPr>
            <a:lvl8pPr>
              <a:defRPr sz="2067"/>
            </a:lvl8pPr>
            <a:lvl9pPr>
              <a:defRPr sz="20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267902"/>
            <a:ext cx="4063824" cy="4201570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09686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1" y="503978"/>
            <a:ext cx="4063824" cy="1763924"/>
          </a:xfrm>
        </p:spPr>
        <p:txBody>
          <a:bodyPr anchor="b"/>
          <a:lstStyle>
            <a:lvl1pPr>
              <a:defRPr sz="330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088454"/>
            <a:ext cx="6378744" cy="5372269"/>
          </a:xfrm>
        </p:spPr>
        <p:txBody>
          <a:bodyPr anchor="t"/>
          <a:lstStyle>
            <a:lvl1pPr marL="0" indent="0">
              <a:buNone/>
              <a:defRPr sz="3307"/>
            </a:lvl1pPr>
            <a:lvl2pPr marL="472516" indent="0">
              <a:buNone/>
              <a:defRPr sz="2894"/>
            </a:lvl2pPr>
            <a:lvl3pPr marL="945032" indent="0">
              <a:buNone/>
              <a:defRPr sz="2480"/>
            </a:lvl3pPr>
            <a:lvl4pPr marL="1417549" indent="0">
              <a:buNone/>
              <a:defRPr sz="2067"/>
            </a:lvl4pPr>
            <a:lvl5pPr marL="1890065" indent="0">
              <a:buNone/>
              <a:defRPr sz="2067"/>
            </a:lvl5pPr>
            <a:lvl6pPr marL="2362581" indent="0">
              <a:buNone/>
              <a:defRPr sz="2067"/>
            </a:lvl6pPr>
            <a:lvl7pPr marL="2835097" indent="0">
              <a:buNone/>
              <a:defRPr sz="2067"/>
            </a:lvl7pPr>
            <a:lvl8pPr marL="3307613" indent="0">
              <a:buNone/>
              <a:defRPr sz="2067"/>
            </a:lvl8pPr>
            <a:lvl9pPr marL="3780130" indent="0">
              <a:buNone/>
              <a:defRPr sz="20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1" y="2267902"/>
            <a:ext cx="4063824" cy="4201570"/>
          </a:xfrm>
        </p:spPr>
        <p:txBody>
          <a:bodyPr/>
          <a:lstStyle>
            <a:lvl1pPr marL="0" indent="0">
              <a:buNone/>
              <a:defRPr sz="1654"/>
            </a:lvl1pPr>
            <a:lvl2pPr marL="472516" indent="0">
              <a:buNone/>
              <a:defRPr sz="1447"/>
            </a:lvl2pPr>
            <a:lvl3pPr marL="945032" indent="0">
              <a:buNone/>
              <a:defRPr sz="1240"/>
            </a:lvl3pPr>
            <a:lvl4pPr marL="1417549" indent="0">
              <a:buNone/>
              <a:defRPr sz="1034"/>
            </a:lvl4pPr>
            <a:lvl5pPr marL="1890065" indent="0">
              <a:buNone/>
              <a:defRPr sz="1034"/>
            </a:lvl5pPr>
            <a:lvl6pPr marL="2362581" indent="0">
              <a:buNone/>
              <a:defRPr sz="1034"/>
            </a:lvl6pPr>
            <a:lvl7pPr marL="2835097" indent="0">
              <a:buNone/>
              <a:defRPr sz="1034"/>
            </a:lvl7pPr>
            <a:lvl8pPr marL="3307613" indent="0">
              <a:buNone/>
              <a:defRPr sz="1034"/>
            </a:lvl8pPr>
            <a:lvl9pPr marL="3780130" indent="0">
              <a:buNone/>
              <a:defRPr sz="1034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109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402483"/>
            <a:ext cx="10867490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012414"/>
            <a:ext cx="10867490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7006699"/>
            <a:ext cx="283499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ECDA9-CFA9-43C1-A507-4F4699F8A162}" type="datetimeFigureOut">
              <a:rPr lang="he-IL" smtClean="0"/>
              <a:t>כ"א/שבט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7006699"/>
            <a:ext cx="4252496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7006699"/>
            <a:ext cx="2834997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3BE4CC-4168-4674-8668-51BD6C103AFA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0702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45032" rtl="1" eaLnBrk="1" latinLnBrk="0" hangingPunct="1">
        <a:lnSpc>
          <a:spcPct val="90000"/>
        </a:lnSpc>
        <a:spcBef>
          <a:spcPct val="0"/>
        </a:spcBef>
        <a:buNone/>
        <a:defRPr sz="45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6258" indent="-236258" algn="r" defTabSz="945032" rtl="1" eaLnBrk="1" latinLnBrk="0" hangingPunct="1">
        <a:lnSpc>
          <a:spcPct val="90000"/>
        </a:lnSpc>
        <a:spcBef>
          <a:spcPts val="1034"/>
        </a:spcBef>
        <a:buFont typeface="Arial" panose="020B0604020202020204" pitchFamily="34" charset="0"/>
        <a:buChar char="•"/>
        <a:defRPr sz="2894" kern="1200">
          <a:solidFill>
            <a:schemeClr val="tx1"/>
          </a:solidFill>
          <a:latin typeface="+mn-lt"/>
          <a:ea typeface="+mn-ea"/>
          <a:cs typeface="+mn-cs"/>
        </a:defRPr>
      </a:lvl1pPr>
      <a:lvl2pPr marL="708774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181291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2067" kern="1200">
          <a:solidFill>
            <a:schemeClr val="tx1"/>
          </a:solidFill>
          <a:latin typeface="+mn-lt"/>
          <a:ea typeface="+mn-ea"/>
          <a:cs typeface="+mn-cs"/>
        </a:defRPr>
      </a:lvl3pPr>
      <a:lvl4pPr marL="1653807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2126323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598839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3071355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543872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4016388" indent="-236258" algn="r" defTabSz="945032" rtl="1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1pPr>
      <a:lvl2pPr marL="472516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2pPr>
      <a:lvl3pPr marL="945032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3pPr>
      <a:lvl4pPr marL="1417549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4pPr>
      <a:lvl5pPr marL="1890065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5pPr>
      <a:lvl6pPr marL="2362581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6pPr>
      <a:lvl7pPr marL="2835097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7pPr>
      <a:lvl8pPr marL="3307613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8pPr>
      <a:lvl9pPr marL="3780130" algn="r" defTabSz="945032" rtl="1" eaLnBrk="1" latinLnBrk="0" hangingPunct="1">
        <a:defRPr sz="18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50795" y="143836"/>
            <a:ext cx="12098398" cy="7315201"/>
            <a:chOff x="93601" y="0"/>
            <a:chExt cx="12098398" cy="7315201"/>
          </a:xfrm>
        </p:grpSpPr>
        <p:sp>
          <p:nvSpPr>
            <p:cNvPr id="5" name="Rectangle 4"/>
            <p:cNvSpPr/>
            <p:nvPr/>
          </p:nvSpPr>
          <p:spPr>
            <a:xfrm>
              <a:off x="120072" y="0"/>
              <a:ext cx="12071927" cy="232217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36195" indent="180340"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b="1" dirty="0">
                  <a:latin typeface="Times New Roman" panose="02020603050405020304" pitchFamily="18" charset="0"/>
                </a:rPr>
                <a:t>Figure </a:t>
              </a:r>
              <a:r>
                <a:rPr lang="en-US" b="1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S2</a:t>
              </a: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Arial" panose="020B0604020202020204" pitchFamily="34" charset="0"/>
                </a:rPr>
                <a:t>: </a:t>
              </a:r>
              <a:r>
                <a:rPr lang="en-US" dirty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Working MFC operating for over 80 days </a:t>
              </a:r>
              <a:r>
                <a:rPr lang="en-US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from </a:t>
              </a:r>
              <a:r>
                <a:rPr lang="en-US" smtClean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which an </a:t>
              </a:r>
              <a:r>
                <a:rPr lang="en-US" dirty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anode sample was taken (day 40) for enriching the electroactive consortium </a:t>
              </a:r>
              <a:r>
                <a:rPr lang="en-US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(</a:t>
              </a:r>
              <a:r>
                <a:rPr lang="en-US" smtClean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EDC):</a:t>
              </a:r>
              <a:endPara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David" panose="020E0502060401010101" pitchFamily="34" charset="-79"/>
              </a:endParaRPr>
            </a:p>
            <a:p>
              <a:pPr marL="379095" indent="-342900" algn="just">
                <a:lnSpc>
                  <a:spcPct val="115000"/>
                </a:lnSpc>
                <a:spcAft>
                  <a:spcPts val="0"/>
                </a:spcAft>
                <a:buAutoNum type="alphaUcParenR"/>
              </a:pPr>
              <a:r>
                <a:rPr lang="en-US" dirty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Relative abundance of bacterial families in the anode-biofilm samples sampled at different time points. </a:t>
              </a:r>
            </a:p>
            <a:p>
              <a:pPr marL="36195" algn="just">
                <a:lnSpc>
                  <a:spcPct val="115000"/>
                </a:lnSpc>
                <a:spcAft>
                  <a:spcPts val="0"/>
                </a:spcAft>
              </a:pPr>
              <a:r>
                <a:rPr lang="en-US" dirty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B) </a:t>
              </a:r>
              <a:r>
                <a:rPr lang="en-US" dirty="0">
                  <a:latin typeface="Times New Roman" panose="02020603050405020304" pitchFamily="18" charset="0"/>
                  <a:cs typeface="David" panose="020E0502060401010101" pitchFamily="34" charset="-79"/>
                </a:rPr>
                <a:t>Voltage generation plotted with the relative abundance of the families </a:t>
              </a:r>
              <a:r>
                <a:rPr lang="en-US" i="1" dirty="0" err="1">
                  <a:latin typeface="Times New Roman" panose="02020603050405020304" pitchFamily="18" charset="0"/>
                  <a:cs typeface="David" panose="020E0502060401010101" pitchFamily="34" charset="-79"/>
                </a:rPr>
                <a:t>Desulfuromonadaceae</a:t>
              </a:r>
              <a:r>
                <a:rPr lang="en-US" dirty="0">
                  <a:latin typeface="Times New Roman" panose="02020603050405020304" pitchFamily="18" charset="0"/>
                  <a:cs typeface="David" panose="020E0502060401010101" pitchFamily="34" charset="-79"/>
                </a:rPr>
                <a:t> and </a:t>
              </a:r>
              <a:r>
                <a:rPr lang="en-US" i="1" dirty="0" err="1">
                  <a:latin typeface="Times New Roman" panose="02020603050405020304" pitchFamily="18" charset="0"/>
                  <a:cs typeface="David" panose="020E0502060401010101" pitchFamily="34" charset="-79"/>
                </a:rPr>
                <a:t>Geobacteraceae</a:t>
              </a:r>
              <a:r>
                <a:rPr lang="en-US" dirty="0">
                  <a:latin typeface="Times New Roman" panose="02020603050405020304" pitchFamily="18" charset="0"/>
                  <a:cs typeface="David" panose="020E0502060401010101" pitchFamily="34" charset="-79"/>
                </a:rPr>
                <a:t> (δ-Proteobacteria) sampled from the planktonic phase at different time points and bar graphs of OTU relative abundance distribution of the anodic-biofilm (δ-Proteobacteria OTUs only) sampled at different time points. Since the total δ-Proteobacteria</a:t>
              </a:r>
              <a:br>
                <a:rPr lang="en-US" dirty="0">
                  <a:latin typeface="Times New Roman" panose="02020603050405020304" pitchFamily="18" charset="0"/>
                  <a:cs typeface="David" panose="020E0502060401010101" pitchFamily="34" charset="-79"/>
                </a:rPr>
              </a:br>
              <a:r>
                <a:rPr lang="en-US" dirty="0">
                  <a:latin typeface="Times New Roman" panose="02020603050405020304" pitchFamily="18" charset="0"/>
                  <a:cs typeface="David" panose="020E0502060401010101" pitchFamily="34" charset="-79"/>
                </a:rPr>
                <a:t>abundance on day 6 was &lt; 2%, inset expands data for relative abundance of this day.</a:t>
              </a:r>
            </a:p>
          </p:txBody>
        </p:sp>
        <p:grpSp>
          <p:nvGrpSpPr>
            <p:cNvPr id="6" name="קבוצה 6">
              <a:extLst>
                <a:ext uri="{FF2B5EF4-FFF2-40B4-BE49-F238E27FC236}">
                  <a16:creationId xmlns:a16="http://schemas.microsoft.com/office/drawing/2014/main" id="{A5AC04FA-6011-4A14-8AFD-4DE6C1B6D36C}"/>
                </a:ext>
              </a:extLst>
            </p:cNvPr>
            <p:cNvGrpSpPr/>
            <p:nvPr/>
          </p:nvGrpSpPr>
          <p:grpSpPr>
            <a:xfrm>
              <a:off x="419331" y="2461078"/>
              <a:ext cx="4634807" cy="3249766"/>
              <a:chOff x="5960225" y="2144946"/>
              <a:chExt cx="6035024" cy="4280792"/>
            </a:xfrm>
          </p:grpSpPr>
          <p:pic>
            <p:nvPicPr>
              <p:cNvPr id="15" name="תמונה 1">
                <a:extLst>
                  <a:ext uri="{FF2B5EF4-FFF2-40B4-BE49-F238E27FC236}">
                    <a16:creationId xmlns:a16="http://schemas.microsoft.com/office/drawing/2014/main" id="{CD0E0009-7538-4EA9-9D03-DC5CD34FED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960225" y="2144946"/>
                <a:ext cx="6035024" cy="4280792"/>
              </a:xfrm>
              <a:prstGeom prst="rect">
                <a:avLst/>
              </a:prstGeom>
            </p:spPr>
          </p:pic>
          <p:sp>
            <p:nvSpPr>
              <p:cNvPr id="16" name="מלבן 4">
                <a:extLst>
                  <a:ext uri="{FF2B5EF4-FFF2-40B4-BE49-F238E27FC236}">
                    <a16:creationId xmlns:a16="http://schemas.microsoft.com/office/drawing/2014/main" id="{0271CB3E-5F50-4C16-8B3D-DEA2C26FA8A1}"/>
                  </a:ext>
                </a:extLst>
              </p:cNvPr>
              <p:cNvSpPr/>
              <p:nvPr/>
            </p:nvSpPr>
            <p:spPr>
              <a:xfrm>
                <a:off x="9484822" y="2144946"/>
                <a:ext cx="648393" cy="285931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 dirty="0"/>
              </a:p>
            </p:txBody>
          </p:sp>
        </p:grpSp>
        <p:sp>
          <p:nvSpPr>
            <p:cNvPr id="7" name="מלבן 9">
              <a:extLst>
                <a:ext uri="{FF2B5EF4-FFF2-40B4-BE49-F238E27FC236}">
                  <a16:creationId xmlns:a16="http://schemas.microsoft.com/office/drawing/2014/main" id="{39FC24A9-CFDF-43F2-8C9A-3EBA814F85A5}"/>
                </a:ext>
              </a:extLst>
            </p:cNvPr>
            <p:cNvSpPr/>
            <p:nvPr/>
          </p:nvSpPr>
          <p:spPr>
            <a:xfrm>
              <a:off x="93601" y="2296654"/>
              <a:ext cx="33214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A</a:t>
              </a:r>
              <a:endParaRPr lang="he-IL" sz="1600" dirty="0"/>
            </a:p>
          </p:txBody>
        </p:sp>
        <p:sp>
          <p:nvSpPr>
            <p:cNvPr id="8" name="מלבן 10">
              <a:extLst>
                <a:ext uri="{FF2B5EF4-FFF2-40B4-BE49-F238E27FC236}">
                  <a16:creationId xmlns:a16="http://schemas.microsoft.com/office/drawing/2014/main" id="{8435F2C5-FCF3-4C13-9C6C-E35000837DFC}"/>
                </a:ext>
              </a:extLst>
            </p:cNvPr>
            <p:cNvSpPr/>
            <p:nvPr/>
          </p:nvSpPr>
          <p:spPr>
            <a:xfrm>
              <a:off x="5150962" y="2291801"/>
              <a:ext cx="332142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600" dirty="0">
                  <a:latin typeface="Times New Roman" panose="02020603050405020304" pitchFamily="18" charset="0"/>
                  <a:ea typeface="Times New Roman" panose="02020603050405020304" pitchFamily="18" charset="0"/>
                  <a:cs typeface="David" panose="020E0502060401010101" pitchFamily="34" charset="-79"/>
                </a:rPr>
                <a:t>B</a:t>
              </a:r>
              <a:endParaRPr lang="he-IL" sz="1600" dirty="0"/>
            </a:p>
          </p:txBody>
        </p:sp>
        <p:grpSp>
          <p:nvGrpSpPr>
            <p:cNvPr id="9" name="קבוצה 14">
              <a:extLst>
                <a:ext uri="{FF2B5EF4-FFF2-40B4-BE49-F238E27FC236}">
                  <a16:creationId xmlns:a16="http://schemas.microsoft.com/office/drawing/2014/main" id="{98BFD0CE-77A0-4BA1-BF87-4F997F8F9BB4}"/>
                </a:ext>
              </a:extLst>
            </p:cNvPr>
            <p:cNvGrpSpPr/>
            <p:nvPr/>
          </p:nvGrpSpPr>
          <p:grpSpPr>
            <a:xfrm>
              <a:off x="5317033" y="2461079"/>
              <a:ext cx="4059723" cy="4854122"/>
              <a:chOff x="5317033" y="2461079"/>
              <a:chExt cx="4059723" cy="4854122"/>
            </a:xfrm>
          </p:grpSpPr>
          <p:grpSp>
            <p:nvGrpSpPr>
              <p:cNvPr id="10" name="קבוצה 8">
                <a:extLst>
                  <a:ext uri="{FF2B5EF4-FFF2-40B4-BE49-F238E27FC236}">
                    <a16:creationId xmlns:a16="http://schemas.microsoft.com/office/drawing/2014/main" id="{EC88C7DC-53D1-43D1-9AB9-7FB12BCD3E59}"/>
                  </a:ext>
                </a:extLst>
              </p:cNvPr>
              <p:cNvGrpSpPr/>
              <p:nvPr/>
            </p:nvGrpSpPr>
            <p:grpSpPr>
              <a:xfrm>
                <a:off x="5317033" y="2461079"/>
                <a:ext cx="4059723" cy="4854122"/>
                <a:chOff x="5769032" y="2028821"/>
                <a:chExt cx="4887884" cy="5741871"/>
              </a:xfrm>
            </p:grpSpPr>
            <p:pic>
              <p:nvPicPr>
                <p:cNvPr id="13" name="תמונה 5">
                  <a:extLst>
                    <a:ext uri="{FF2B5EF4-FFF2-40B4-BE49-F238E27FC236}">
                      <a16:creationId xmlns:a16="http://schemas.microsoft.com/office/drawing/2014/main" id="{2409FA2C-95FC-4A09-9F5D-77D1FBE58D8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769032" y="2028821"/>
                  <a:ext cx="4887884" cy="5741871"/>
                </a:xfrm>
                <a:prstGeom prst="rect">
                  <a:avLst/>
                </a:prstGeom>
              </p:spPr>
            </p:pic>
            <p:sp>
              <p:nvSpPr>
                <p:cNvPr id="14" name="מלבן 7">
                  <a:extLst>
                    <a:ext uri="{FF2B5EF4-FFF2-40B4-BE49-F238E27FC236}">
                      <a16:creationId xmlns:a16="http://schemas.microsoft.com/office/drawing/2014/main" id="{A5EF07BD-C723-42AD-9524-8C97B3AC5A62}"/>
                    </a:ext>
                  </a:extLst>
                </p:cNvPr>
                <p:cNvSpPr/>
                <p:nvPr/>
              </p:nvSpPr>
              <p:spPr>
                <a:xfrm>
                  <a:off x="8212974" y="5037513"/>
                  <a:ext cx="457201" cy="606830"/>
                </a:xfrm>
                <a:prstGeom prst="rect">
                  <a:avLst/>
                </a:prstGeom>
                <a:noFill/>
                <a:ln>
                  <a:solidFill>
                    <a:srgbClr val="FF0000"/>
                  </a:solidFill>
                  <a:prstDash val="sysDot"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1" anchor="ctr"/>
                <a:lstStyle/>
                <a:p>
                  <a:pPr algn="ctr"/>
                  <a:endParaRPr lang="he-IL" dirty="0"/>
                </a:p>
              </p:txBody>
            </p:sp>
          </p:grpSp>
          <p:sp>
            <p:nvSpPr>
              <p:cNvPr id="11" name="אליפסה 12">
                <a:extLst>
                  <a:ext uri="{FF2B5EF4-FFF2-40B4-BE49-F238E27FC236}">
                    <a16:creationId xmlns:a16="http://schemas.microsoft.com/office/drawing/2014/main" id="{B2098D58-D8C3-45DE-8840-E5942BBA5C56}"/>
                  </a:ext>
                </a:extLst>
              </p:cNvPr>
              <p:cNvSpPr/>
              <p:nvPr/>
            </p:nvSpPr>
            <p:spPr>
              <a:xfrm>
                <a:off x="5561215" y="2884516"/>
                <a:ext cx="199505" cy="15794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 dirty="0"/>
              </a:p>
            </p:txBody>
          </p:sp>
          <p:sp>
            <p:nvSpPr>
              <p:cNvPr id="12" name="אליפסה 13">
                <a:extLst>
                  <a:ext uri="{FF2B5EF4-FFF2-40B4-BE49-F238E27FC236}">
                    <a16:creationId xmlns:a16="http://schemas.microsoft.com/office/drawing/2014/main" id="{57F21D84-58DE-471A-A1A6-A7388FF86A22}"/>
                  </a:ext>
                </a:extLst>
              </p:cNvPr>
              <p:cNvSpPr/>
              <p:nvPr/>
            </p:nvSpPr>
            <p:spPr>
              <a:xfrm>
                <a:off x="5561214" y="3928019"/>
                <a:ext cx="199505" cy="15794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1" anchor="ctr"/>
              <a:lstStyle/>
              <a:p>
                <a:pPr algn="ctr"/>
                <a:endParaRPr lang="he-IL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41828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99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David</vt:lpstr>
      <vt:lpstr>Times New Roman</vt:lpstr>
      <vt:lpstr>Office Theme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ren Yanuka-Golub</dc:creator>
  <cp:lastModifiedBy>Keren Yanuka-Golub</cp:lastModifiedBy>
  <cp:revision>2</cp:revision>
  <dcterms:created xsi:type="dcterms:W3CDTF">2020-02-16T09:13:00Z</dcterms:created>
  <dcterms:modified xsi:type="dcterms:W3CDTF">2020-02-16T09:16:16Z</dcterms:modified>
</cp:coreProperties>
</file>